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4" r:id="rId2"/>
    <p:sldId id="273" r:id="rId3"/>
    <p:sldId id="272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ARCIAGUEDEZ,DANIELAALEJANDRA" initials="G" lastIdx="1" clrIdx="0">
    <p:extLst>
      <p:ext uri="{19B8F6BF-5375-455C-9EA6-DF929625EA0E}">
        <p15:presenceInfo xmlns:p15="http://schemas.microsoft.com/office/powerpoint/2012/main" userId="S::2014462037@o365.yonsei.ac.kr::7408f64c-a5b1-4df6-a2bc-d3fde1e776ef" providerId="AD"/>
      </p:ext>
    </p:extLst>
  </p:cmAuthor>
  <p:cmAuthor id="2" name="Windows 사용자" initials="W사" lastIdx="1" clrIdx="1">
    <p:extLst>
      <p:ext uri="{19B8F6BF-5375-455C-9EA6-DF929625EA0E}">
        <p15:presenceInfo xmlns:p15="http://schemas.microsoft.com/office/powerpoint/2012/main" userId="Windows 사용자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EE965"/>
    <a:srgbClr val="008000"/>
    <a:srgbClr val="0000FF"/>
    <a:srgbClr val="0052AC"/>
    <a:srgbClr val="FFA500"/>
    <a:srgbClr val="C1C1C1"/>
    <a:srgbClr val="00007D"/>
    <a:srgbClr val="888888"/>
    <a:srgbClr val="FFFF2F"/>
    <a:srgbClr val="0000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34" autoAdjust="0"/>
    <p:restoredTop sz="94660"/>
  </p:normalViewPr>
  <p:slideViewPr>
    <p:cSldViewPr snapToGrid="0">
      <p:cViewPr varScale="1">
        <p:scale>
          <a:sx n="47" d="100"/>
          <a:sy n="47" d="100"/>
        </p:scale>
        <p:origin x="24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Pne%20metagenic%20analysis\Chemical\Taxonomy_abundance_ratio%20(the%20many%20graphs%20done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Pne%20metagenic%20analysis\Chemical\Taxonomy_abundance_ratio%20(the%20many%20graphs%20done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Pne%20metagenic%20analysis\Chemical\Taxonomy_abundance_ratio%20(the%20many%20graphs%20done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Pne%20metagenic%20analysis\Chemical\Taxonomy_abundance_ratio%20(the%20many%20graphs%20done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Pne%20metagenic%20analysis\Chemical\Taxonomy_abundance_ratio%20(working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Pne%20metagenic%20analysis\Chemical\Taxonomy_abundance_ratio%20(working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Pne%20metagenic%20analysis\Chemical\Taxonomy_abundance_ratio%20(working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Pne%20metagenic%20analysis\Chemical\Taxonomy_abundance_ratio%20(working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amily!$U$610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amily!$T$611:$T$621</c:f>
              <c:strCache>
                <c:ptCount val="11"/>
                <c:pt idx="0">
                  <c:v>Chitinophagaceae</c:v>
                </c:pt>
                <c:pt idx="1">
                  <c:v>Bradyrhizobiaceae</c:v>
                </c:pt>
                <c:pt idx="2">
                  <c:v>Acetobacteraceae</c:v>
                </c:pt>
                <c:pt idx="3">
                  <c:v>Brucellaceae</c:v>
                </c:pt>
                <c:pt idx="4">
                  <c:v>Solirubrobacteraceae</c:v>
                </c:pt>
                <c:pt idx="5">
                  <c:v>Parachlamydiaceae</c:v>
                </c:pt>
                <c:pt idx="6">
                  <c:v>Hymenobacteraceae</c:v>
                </c:pt>
                <c:pt idx="7">
                  <c:v>Flavobacteriaceae</c:v>
                </c:pt>
                <c:pt idx="8">
                  <c:v>Paenibacillaceae</c:v>
                </c:pt>
                <c:pt idx="9">
                  <c:v>Criblamydiaceae</c:v>
                </c:pt>
                <c:pt idx="10">
                  <c:v>Patulibacteraceae</c:v>
                </c:pt>
              </c:strCache>
            </c:strRef>
          </c:cat>
          <c:val>
            <c:numRef>
              <c:f>Family!$U$611:$U$621</c:f>
              <c:numCache>
                <c:formatCode>0.00%</c:formatCode>
                <c:ptCount val="11"/>
                <c:pt idx="0">
                  <c:v>9.6183093110800005E-2</c:v>
                </c:pt>
                <c:pt idx="1">
                  <c:v>5.9059383028975E-3</c:v>
                </c:pt>
                <c:pt idx="2">
                  <c:v>5.9535459221725E-3</c:v>
                </c:pt>
                <c:pt idx="3">
                  <c:v>3.1448525534074996E-3</c:v>
                </c:pt>
                <c:pt idx="4">
                  <c:v>3.6458815643662499E-4</c:v>
                </c:pt>
                <c:pt idx="5">
                  <c:v>3.5200310214832499E-4</c:v>
                </c:pt>
                <c:pt idx="6">
                  <c:v>0</c:v>
                </c:pt>
                <c:pt idx="7">
                  <c:v>1.6785538855025001E-4</c:v>
                </c:pt>
                <c:pt idx="8">
                  <c:v>4.4726324149225007E-4</c:v>
                </c:pt>
                <c:pt idx="9">
                  <c:v>6.1675226398150005E-5</c:v>
                </c:pt>
                <c:pt idx="10">
                  <c:v>1.707313138313250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01-4B7A-A99D-30EBD6B987EF}"/>
            </c:ext>
          </c:extLst>
        </c:ser>
        <c:ser>
          <c:idx val="1"/>
          <c:order val="1"/>
          <c:tx>
            <c:strRef>
              <c:f>Family!$V$610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Family!$T$611:$T$621</c:f>
              <c:strCache>
                <c:ptCount val="11"/>
                <c:pt idx="0">
                  <c:v>Chitinophagaceae</c:v>
                </c:pt>
                <c:pt idx="1">
                  <c:v>Bradyrhizobiaceae</c:v>
                </c:pt>
                <c:pt idx="2">
                  <c:v>Acetobacteraceae</c:v>
                </c:pt>
                <c:pt idx="3">
                  <c:v>Brucellaceae</c:v>
                </c:pt>
                <c:pt idx="4">
                  <c:v>Solirubrobacteraceae</c:v>
                </c:pt>
                <c:pt idx="5">
                  <c:v>Parachlamydiaceae</c:v>
                </c:pt>
                <c:pt idx="6">
                  <c:v>Hymenobacteraceae</c:v>
                </c:pt>
                <c:pt idx="7">
                  <c:v>Flavobacteriaceae</c:v>
                </c:pt>
                <c:pt idx="8">
                  <c:v>Paenibacillaceae</c:v>
                </c:pt>
                <c:pt idx="9">
                  <c:v>Criblamydiaceae</c:v>
                </c:pt>
                <c:pt idx="10">
                  <c:v>Patulibacteraceae</c:v>
                </c:pt>
              </c:strCache>
            </c:strRef>
          </c:cat>
          <c:val>
            <c:numRef>
              <c:f>Family!$V$611:$V$621</c:f>
              <c:numCache>
                <c:formatCode>0.00%</c:formatCode>
                <c:ptCount val="11"/>
                <c:pt idx="0">
                  <c:v>9.9031919489100007E-2</c:v>
                </c:pt>
                <c:pt idx="1">
                  <c:v>6.2303337158725004E-3</c:v>
                </c:pt>
                <c:pt idx="2">
                  <c:v>5.3462615635824998E-3</c:v>
                </c:pt>
                <c:pt idx="3">
                  <c:v>2.9841652471275003E-3</c:v>
                </c:pt>
                <c:pt idx="4">
                  <c:v>5.610580630542501E-4</c:v>
                </c:pt>
                <c:pt idx="5">
                  <c:v>4.3739351643324996E-4</c:v>
                </c:pt>
                <c:pt idx="6">
                  <c:v>2.4220026671827502E-4</c:v>
                </c:pt>
                <c:pt idx="7">
                  <c:v>3.4625174648175001E-4</c:v>
                </c:pt>
                <c:pt idx="8">
                  <c:v>5.3987417538774998E-4</c:v>
                </c:pt>
                <c:pt idx="9">
                  <c:v>4.5779161325750003E-5</c:v>
                </c:pt>
                <c:pt idx="10">
                  <c:v>9.1418675532750003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F01-4B7A-A99D-30EBD6B987EF}"/>
            </c:ext>
          </c:extLst>
        </c:ser>
        <c:ser>
          <c:idx val="2"/>
          <c:order val="2"/>
          <c:tx>
            <c:strRef>
              <c:f>Family!$W$610</c:f>
              <c:strCache>
                <c:ptCount val="1"/>
                <c:pt idx="0">
                  <c:v>NM</c:v>
                </c:pt>
              </c:strCache>
            </c:strRef>
          </c:tx>
          <c:spPr>
            <a:solidFill>
              <a:srgbClr val="6EE965"/>
            </a:solidFill>
            <a:ln>
              <a:noFill/>
            </a:ln>
            <a:effectLst/>
          </c:spPr>
          <c:invertIfNegative val="0"/>
          <c:cat>
            <c:strRef>
              <c:f>Family!$T$611:$T$621</c:f>
              <c:strCache>
                <c:ptCount val="11"/>
                <c:pt idx="0">
                  <c:v>Chitinophagaceae</c:v>
                </c:pt>
                <c:pt idx="1">
                  <c:v>Bradyrhizobiaceae</c:v>
                </c:pt>
                <c:pt idx="2">
                  <c:v>Acetobacteraceae</c:v>
                </c:pt>
                <c:pt idx="3">
                  <c:v>Brucellaceae</c:v>
                </c:pt>
                <c:pt idx="4">
                  <c:v>Solirubrobacteraceae</c:v>
                </c:pt>
                <c:pt idx="5">
                  <c:v>Parachlamydiaceae</c:v>
                </c:pt>
                <c:pt idx="6">
                  <c:v>Hymenobacteraceae</c:v>
                </c:pt>
                <c:pt idx="7">
                  <c:v>Flavobacteriaceae</c:v>
                </c:pt>
                <c:pt idx="8">
                  <c:v>Paenibacillaceae</c:v>
                </c:pt>
                <c:pt idx="9">
                  <c:v>Criblamydiaceae</c:v>
                </c:pt>
                <c:pt idx="10">
                  <c:v>Patulibacteraceae</c:v>
                </c:pt>
              </c:strCache>
            </c:strRef>
          </c:cat>
          <c:val>
            <c:numRef>
              <c:f>Family!$W$611:$W$621</c:f>
              <c:numCache>
                <c:formatCode>0.00%</c:formatCode>
                <c:ptCount val="11"/>
                <c:pt idx="0">
                  <c:v>7.6581342491374993E-2</c:v>
                </c:pt>
                <c:pt idx="1">
                  <c:v>9.3875827990999999E-3</c:v>
                </c:pt>
                <c:pt idx="2">
                  <c:v>9.5613727559474993E-3</c:v>
                </c:pt>
                <c:pt idx="3">
                  <c:v>1.5406612357575001E-3</c:v>
                </c:pt>
                <c:pt idx="4">
                  <c:v>1.3569499795175E-4</c:v>
                </c:pt>
                <c:pt idx="5">
                  <c:v>9.0928718266899999E-4</c:v>
                </c:pt>
                <c:pt idx="6">
                  <c:v>1.6292198152439998E-3</c:v>
                </c:pt>
                <c:pt idx="7">
                  <c:v>9.4322941433974997E-4</c:v>
                </c:pt>
                <c:pt idx="8">
                  <c:v>8.8874837446749997E-5</c:v>
                </c:pt>
                <c:pt idx="9">
                  <c:v>4.1774893049000006E-4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F01-4B7A-A99D-30EBD6B987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1308064800"/>
        <c:axId val="1308056896"/>
      </c:barChart>
      <c:catAx>
        <c:axId val="1308064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08056896"/>
        <c:crosses val="autoZero"/>
        <c:auto val="1"/>
        <c:lblAlgn val="ctr"/>
        <c:lblOffset val="100"/>
        <c:noMultiLvlLbl val="0"/>
      </c:catAx>
      <c:valAx>
        <c:axId val="1308056896"/>
        <c:scaling>
          <c:orientation val="minMax"/>
          <c:max val="0.1"/>
        </c:scaling>
        <c:delete val="0"/>
        <c:axPos val="l"/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08064800"/>
        <c:crosses val="autoZero"/>
        <c:crossBetween val="between"/>
        <c:majorUnit val="2.0000000000000004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Order!$U$433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Order!$T$434:$T$437</c:f>
              <c:strCache>
                <c:ptCount val="4"/>
                <c:pt idx="0">
                  <c:v>Chitinophagales</c:v>
                </c:pt>
                <c:pt idx="1">
                  <c:v>Rhodocyclales</c:v>
                </c:pt>
                <c:pt idx="2">
                  <c:v>Bacillales</c:v>
                </c:pt>
                <c:pt idx="3">
                  <c:v>Solirubrobacterales</c:v>
                </c:pt>
              </c:strCache>
            </c:strRef>
          </c:cat>
          <c:val>
            <c:numRef>
              <c:f>Order!$U$434:$U$437</c:f>
              <c:numCache>
                <c:formatCode>0.00%</c:formatCode>
                <c:ptCount val="4"/>
                <c:pt idx="0">
                  <c:v>9.6183093110800005E-2</c:v>
                </c:pt>
                <c:pt idx="1">
                  <c:v>4.4023624536765E-3</c:v>
                </c:pt>
                <c:pt idx="2">
                  <c:v>1.3762813378332501E-3</c:v>
                </c:pt>
                <c:pt idx="3">
                  <c:v>7.5529643353599999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A5-4B9D-837B-AF060A16ECDB}"/>
            </c:ext>
          </c:extLst>
        </c:ser>
        <c:ser>
          <c:idx val="1"/>
          <c:order val="1"/>
          <c:tx>
            <c:strRef>
              <c:f>Order!$V$433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Order!$T$434:$T$437</c:f>
              <c:strCache>
                <c:ptCount val="4"/>
                <c:pt idx="0">
                  <c:v>Chitinophagales</c:v>
                </c:pt>
                <c:pt idx="1">
                  <c:v>Rhodocyclales</c:v>
                </c:pt>
                <c:pt idx="2">
                  <c:v>Bacillales</c:v>
                </c:pt>
                <c:pt idx="3">
                  <c:v>Solirubrobacterales</c:v>
                </c:pt>
              </c:strCache>
            </c:strRef>
          </c:cat>
          <c:val>
            <c:numRef>
              <c:f>Order!$V$434:$V$437</c:f>
              <c:numCache>
                <c:formatCode>0.00%</c:formatCode>
                <c:ptCount val="4"/>
                <c:pt idx="0">
                  <c:v>9.9031919489100007E-2</c:v>
                </c:pt>
                <c:pt idx="1">
                  <c:v>1.2563245704575E-2</c:v>
                </c:pt>
                <c:pt idx="2">
                  <c:v>1.9390996858012501E-3</c:v>
                </c:pt>
                <c:pt idx="3">
                  <c:v>7.026672959710000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5A5-4B9D-837B-AF060A16ECDB}"/>
            </c:ext>
          </c:extLst>
        </c:ser>
        <c:ser>
          <c:idx val="2"/>
          <c:order val="2"/>
          <c:tx>
            <c:strRef>
              <c:f>Order!$W$433</c:f>
              <c:strCache>
                <c:ptCount val="1"/>
                <c:pt idx="0">
                  <c:v>NM</c:v>
                </c:pt>
              </c:strCache>
            </c:strRef>
          </c:tx>
          <c:spPr>
            <a:solidFill>
              <a:srgbClr val="6EE965"/>
            </a:solidFill>
            <a:ln>
              <a:noFill/>
            </a:ln>
            <a:effectLst/>
          </c:spPr>
          <c:invertIfNegative val="0"/>
          <c:cat>
            <c:strRef>
              <c:f>Order!$T$434:$T$437</c:f>
              <c:strCache>
                <c:ptCount val="4"/>
                <c:pt idx="0">
                  <c:v>Chitinophagales</c:v>
                </c:pt>
                <c:pt idx="1">
                  <c:v>Rhodocyclales</c:v>
                </c:pt>
                <c:pt idx="2">
                  <c:v>Bacillales</c:v>
                </c:pt>
                <c:pt idx="3">
                  <c:v>Solirubrobacterales</c:v>
                </c:pt>
              </c:strCache>
            </c:strRef>
          </c:cat>
          <c:val>
            <c:numRef>
              <c:f>Order!$W$434:$W$437</c:f>
              <c:numCache>
                <c:formatCode>0.00%</c:formatCode>
                <c:ptCount val="4"/>
                <c:pt idx="0">
                  <c:v>7.6581342491374993E-2</c:v>
                </c:pt>
                <c:pt idx="1">
                  <c:v>2.5743433948032503E-2</c:v>
                </c:pt>
                <c:pt idx="2">
                  <c:v>7.0008755902000006E-4</c:v>
                </c:pt>
                <c:pt idx="3">
                  <c:v>2.54148174295675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5A5-4B9D-837B-AF060A16EC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1368131232"/>
        <c:axId val="1368118336"/>
      </c:barChart>
      <c:catAx>
        <c:axId val="136813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8118336"/>
        <c:crosses val="autoZero"/>
        <c:auto val="1"/>
        <c:lblAlgn val="ctr"/>
        <c:lblOffset val="100"/>
        <c:noMultiLvlLbl val="0"/>
      </c:catAx>
      <c:valAx>
        <c:axId val="1368118336"/>
        <c:scaling>
          <c:orientation val="minMax"/>
          <c:max val="0.1"/>
        </c:scaling>
        <c:delete val="0"/>
        <c:axPos val="l"/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8131232"/>
        <c:crosses val="autoZero"/>
        <c:crossBetween val="between"/>
        <c:majorUnit val="2.0000000000000004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hylum!$AA$10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Phylum!$Z$102</c:f>
              <c:strCache>
                <c:ptCount val="1"/>
                <c:pt idx="0">
                  <c:v>Firmicutes</c:v>
                </c:pt>
              </c:strCache>
            </c:strRef>
          </c:cat>
          <c:val>
            <c:numRef>
              <c:f>Phylum!$AA$102</c:f>
              <c:numCache>
                <c:formatCode>0.00%</c:formatCode>
                <c:ptCount val="1"/>
                <c:pt idx="0">
                  <c:v>3.388969022880000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42-456F-8B4B-93AC5C946C60}"/>
            </c:ext>
          </c:extLst>
        </c:ser>
        <c:ser>
          <c:idx val="1"/>
          <c:order val="1"/>
          <c:tx>
            <c:strRef>
              <c:f>Phylum!$AB$101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Phylum!$Z$102</c:f>
              <c:strCache>
                <c:ptCount val="1"/>
                <c:pt idx="0">
                  <c:v>Firmicutes</c:v>
                </c:pt>
              </c:strCache>
            </c:strRef>
          </c:cat>
          <c:val>
            <c:numRef>
              <c:f>Phylum!$AB$102</c:f>
              <c:numCache>
                <c:formatCode>0.00%</c:formatCode>
                <c:ptCount val="1"/>
                <c:pt idx="0">
                  <c:v>3.419552728124999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42-456F-8B4B-93AC5C946C60}"/>
            </c:ext>
          </c:extLst>
        </c:ser>
        <c:ser>
          <c:idx val="2"/>
          <c:order val="2"/>
          <c:tx>
            <c:strRef>
              <c:f>Phylum!$AC$101</c:f>
              <c:strCache>
                <c:ptCount val="1"/>
                <c:pt idx="0">
                  <c:v>NM</c:v>
                </c:pt>
              </c:strCache>
            </c:strRef>
          </c:tx>
          <c:spPr>
            <a:solidFill>
              <a:srgbClr val="6EE965"/>
            </a:solidFill>
            <a:ln>
              <a:noFill/>
            </a:ln>
            <a:effectLst/>
          </c:spPr>
          <c:invertIfNegative val="0"/>
          <c:cat>
            <c:strRef>
              <c:f>Phylum!$Z$102</c:f>
              <c:strCache>
                <c:ptCount val="1"/>
                <c:pt idx="0">
                  <c:v>Firmicutes</c:v>
                </c:pt>
              </c:strCache>
            </c:strRef>
          </c:cat>
          <c:val>
            <c:numRef>
              <c:f>Phylum!$AC$102</c:f>
              <c:numCache>
                <c:formatCode>0.00%</c:formatCode>
                <c:ptCount val="1"/>
                <c:pt idx="0">
                  <c:v>1.84504908228249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D42-456F-8B4B-93AC5C946C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1368124992"/>
        <c:axId val="1368113760"/>
      </c:barChart>
      <c:catAx>
        <c:axId val="1368124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8113760"/>
        <c:crosses val="autoZero"/>
        <c:auto val="1"/>
        <c:lblAlgn val="ctr"/>
        <c:lblOffset val="100"/>
        <c:noMultiLvlLbl val="0"/>
      </c:catAx>
      <c:valAx>
        <c:axId val="1368113760"/>
        <c:scaling>
          <c:orientation val="minMax"/>
          <c:max val="3.0000000000000009E-3"/>
          <c:min val="0"/>
        </c:scaling>
        <c:delete val="0"/>
        <c:axPos val="l"/>
        <c:numFmt formatCode="0.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8124992"/>
        <c:crosses val="autoZero"/>
        <c:crossBetween val="between"/>
        <c:majorUnit val="1.0000000000000002E-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lass!$Z$170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Class!$Y$171:$Y$173</c:f>
              <c:strCache>
                <c:ptCount val="3"/>
                <c:pt idx="0">
                  <c:v>Gammaproteobacteria</c:v>
                </c:pt>
                <c:pt idx="1">
                  <c:v>Chitinophagia</c:v>
                </c:pt>
                <c:pt idx="2">
                  <c:v>Oligoflexia</c:v>
                </c:pt>
              </c:strCache>
            </c:strRef>
          </c:cat>
          <c:val>
            <c:numRef>
              <c:f>Class!$Z$171:$Z$173</c:f>
              <c:numCache>
                <c:formatCode>0.00%</c:formatCode>
                <c:ptCount val="3"/>
                <c:pt idx="0">
                  <c:v>0.13388544961400001</c:v>
                </c:pt>
                <c:pt idx="1">
                  <c:v>9.6183093110800005E-2</c:v>
                </c:pt>
                <c:pt idx="2">
                  <c:v>2.35721965386749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13-4BBF-853A-9C48118D7A9E}"/>
            </c:ext>
          </c:extLst>
        </c:ser>
        <c:ser>
          <c:idx val="1"/>
          <c:order val="1"/>
          <c:tx>
            <c:strRef>
              <c:f>Class!$AA$170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Class!$Y$171:$Y$173</c:f>
              <c:strCache>
                <c:ptCount val="3"/>
                <c:pt idx="0">
                  <c:v>Gammaproteobacteria</c:v>
                </c:pt>
                <c:pt idx="1">
                  <c:v>Chitinophagia</c:v>
                </c:pt>
                <c:pt idx="2">
                  <c:v>Oligoflexia</c:v>
                </c:pt>
              </c:strCache>
            </c:strRef>
          </c:cat>
          <c:val>
            <c:numRef>
              <c:f>Class!$AA$171:$AA$173</c:f>
              <c:numCache>
                <c:formatCode>0.00%</c:formatCode>
                <c:ptCount val="3"/>
                <c:pt idx="0">
                  <c:v>0.11297823167812499</c:v>
                </c:pt>
                <c:pt idx="1">
                  <c:v>9.9031919489100007E-2</c:v>
                </c:pt>
                <c:pt idx="2">
                  <c:v>2.46379107121250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313-4BBF-853A-9C48118D7A9E}"/>
            </c:ext>
          </c:extLst>
        </c:ser>
        <c:ser>
          <c:idx val="2"/>
          <c:order val="2"/>
          <c:tx>
            <c:strRef>
              <c:f>Class!$AB$170</c:f>
              <c:strCache>
                <c:ptCount val="1"/>
                <c:pt idx="0">
                  <c:v>NM</c:v>
                </c:pt>
              </c:strCache>
            </c:strRef>
          </c:tx>
          <c:spPr>
            <a:solidFill>
              <a:srgbClr val="6EE965"/>
            </a:solidFill>
            <a:ln>
              <a:noFill/>
            </a:ln>
            <a:effectLst/>
          </c:spPr>
          <c:invertIfNegative val="0"/>
          <c:cat>
            <c:strRef>
              <c:f>Class!$Y$171:$Y$173</c:f>
              <c:strCache>
                <c:ptCount val="3"/>
                <c:pt idx="0">
                  <c:v>Gammaproteobacteria</c:v>
                </c:pt>
                <c:pt idx="1">
                  <c:v>Chitinophagia</c:v>
                </c:pt>
                <c:pt idx="2">
                  <c:v>Oligoflexia</c:v>
                </c:pt>
              </c:strCache>
            </c:strRef>
          </c:cat>
          <c:val>
            <c:numRef>
              <c:f>Class!$AB$171:$AB$173</c:f>
              <c:numCache>
                <c:formatCode>0.00%</c:formatCode>
                <c:ptCount val="3"/>
                <c:pt idx="0">
                  <c:v>9.3436396728100002E-2</c:v>
                </c:pt>
                <c:pt idx="1">
                  <c:v>7.6581342491374993E-2</c:v>
                </c:pt>
                <c:pt idx="2">
                  <c:v>1.080298362397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313-4BBF-853A-9C48118D7A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1368119584"/>
        <c:axId val="1368123744"/>
      </c:barChart>
      <c:catAx>
        <c:axId val="1368119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8123744"/>
        <c:crosses val="autoZero"/>
        <c:auto val="1"/>
        <c:lblAlgn val="ctr"/>
        <c:lblOffset val="100"/>
        <c:noMultiLvlLbl val="0"/>
      </c:catAx>
      <c:valAx>
        <c:axId val="1368123744"/>
        <c:scaling>
          <c:orientation val="minMax"/>
          <c:max val="0.14000000000000001"/>
          <c:min val="0"/>
        </c:scaling>
        <c:delete val="0"/>
        <c:axPos val="l"/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8119584"/>
        <c:crosses val="autoZero"/>
        <c:crossBetween val="between"/>
        <c:majorUnit val="3.0000000000000006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amily!$V$797</c:f>
              <c:strCache>
                <c:ptCount val="1"/>
                <c:pt idx="0">
                  <c:v>MA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amily!$U$798:$U$807</c:f>
              <c:strCache>
                <c:ptCount val="10"/>
                <c:pt idx="0">
                  <c:v>Chitinophagaceae</c:v>
                </c:pt>
                <c:pt idx="1">
                  <c:v>Hyphomicrobiaceae</c:v>
                </c:pt>
                <c:pt idx="2">
                  <c:v>Alcaligenaceae</c:v>
                </c:pt>
                <c:pt idx="3">
                  <c:v>Bradyrhizobiaceae</c:v>
                </c:pt>
                <c:pt idx="4">
                  <c:v>Acetobacteraceae</c:v>
                </c:pt>
                <c:pt idx="5">
                  <c:v>Nocardioidaceae</c:v>
                </c:pt>
                <c:pt idx="6">
                  <c:v>Xanthomonadaceae</c:v>
                </c:pt>
                <c:pt idx="7">
                  <c:v>Cytophagaceae</c:v>
                </c:pt>
                <c:pt idx="8">
                  <c:v>Spirochaetaceae</c:v>
                </c:pt>
                <c:pt idx="9">
                  <c:v>Planctomycetaceae</c:v>
                </c:pt>
              </c:strCache>
            </c:strRef>
          </c:cat>
          <c:val>
            <c:numRef>
              <c:f>Family!$V$798:$V$807</c:f>
              <c:numCache>
                <c:formatCode>0.00%</c:formatCode>
                <c:ptCount val="10"/>
                <c:pt idx="0">
                  <c:v>9.6183093110800005E-2</c:v>
                </c:pt>
                <c:pt idx="1">
                  <c:v>3.2664031560324998E-2</c:v>
                </c:pt>
                <c:pt idx="2">
                  <c:v>1.2329278419864999E-2</c:v>
                </c:pt>
                <c:pt idx="3">
                  <c:v>5.9059383028975E-3</c:v>
                </c:pt>
                <c:pt idx="4">
                  <c:v>5.9535459221725E-3</c:v>
                </c:pt>
                <c:pt idx="5">
                  <c:v>7.0436063980524998E-3</c:v>
                </c:pt>
                <c:pt idx="6">
                  <c:v>2.2631058486225E-3</c:v>
                </c:pt>
                <c:pt idx="7">
                  <c:v>1.8091645972714999E-3</c:v>
                </c:pt>
                <c:pt idx="8">
                  <c:v>1.267138053523E-3</c:v>
                </c:pt>
                <c:pt idx="9">
                  <c:v>7.1207039750074996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F7-47B5-93C8-2B2ACDC3A041}"/>
            </c:ext>
          </c:extLst>
        </c:ser>
        <c:ser>
          <c:idx val="1"/>
          <c:order val="1"/>
          <c:tx>
            <c:strRef>
              <c:f>Family!$W$797</c:f>
              <c:strCache>
                <c:ptCount val="1"/>
                <c:pt idx="0">
                  <c:v>NMT.MA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Family!$U$798:$U$807</c:f>
              <c:strCache>
                <c:ptCount val="10"/>
                <c:pt idx="0">
                  <c:v>Chitinophagaceae</c:v>
                </c:pt>
                <c:pt idx="1">
                  <c:v>Hyphomicrobiaceae</c:v>
                </c:pt>
                <c:pt idx="2">
                  <c:v>Alcaligenaceae</c:v>
                </c:pt>
                <c:pt idx="3">
                  <c:v>Bradyrhizobiaceae</c:v>
                </c:pt>
                <c:pt idx="4">
                  <c:v>Acetobacteraceae</c:v>
                </c:pt>
                <c:pt idx="5">
                  <c:v>Nocardioidaceae</c:v>
                </c:pt>
                <c:pt idx="6">
                  <c:v>Xanthomonadaceae</c:v>
                </c:pt>
                <c:pt idx="7">
                  <c:v>Cytophagaceae</c:v>
                </c:pt>
                <c:pt idx="8">
                  <c:v>Spirochaetaceae</c:v>
                </c:pt>
                <c:pt idx="9">
                  <c:v>Planctomycetaceae</c:v>
                </c:pt>
              </c:strCache>
            </c:strRef>
          </c:cat>
          <c:val>
            <c:numRef>
              <c:f>Family!$W$798:$W$807</c:f>
              <c:numCache>
                <c:formatCode>0.00%</c:formatCode>
                <c:ptCount val="10"/>
                <c:pt idx="0">
                  <c:v>9.9031919489100007E-2</c:v>
                </c:pt>
                <c:pt idx="1">
                  <c:v>4.2999992560175004E-2</c:v>
                </c:pt>
                <c:pt idx="2">
                  <c:v>9.962733162335001E-3</c:v>
                </c:pt>
                <c:pt idx="3">
                  <c:v>6.2303337158725004E-3</c:v>
                </c:pt>
                <c:pt idx="4">
                  <c:v>5.3462615635824998E-3</c:v>
                </c:pt>
                <c:pt idx="5">
                  <c:v>4.1171517885599997E-3</c:v>
                </c:pt>
                <c:pt idx="6">
                  <c:v>2.8894295127574999E-3</c:v>
                </c:pt>
                <c:pt idx="7">
                  <c:v>3.4764618967249999E-3</c:v>
                </c:pt>
                <c:pt idx="8">
                  <c:v>1.5593604680375001E-3</c:v>
                </c:pt>
                <c:pt idx="9">
                  <c:v>9.0732062768449995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0F7-47B5-93C8-2B2ACDC3A041}"/>
            </c:ext>
          </c:extLst>
        </c:ser>
        <c:ser>
          <c:idx val="2"/>
          <c:order val="2"/>
          <c:tx>
            <c:strRef>
              <c:f>Family!$X$797</c:f>
              <c:strCache>
                <c:ptCount val="1"/>
                <c:pt idx="0">
                  <c:v>NMT.MAA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Family!$U$798:$U$807</c:f>
              <c:strCache>
                <c:ptCount val="10"/>
                <c:pt idx="0">
                  <c:v>Chitinophagaceae</c:v>
                </c:pt>
                <c:pt idx="1">
                  <c:v>Hyphomicrobiaceae</c:v>
                </c:pt>
                <c:pt idx="2">
                  <c:v>Alcaligenaceae</c:v>
                </c:pt>
                <c:pt idx="3">
                  <c:v>Bradyrhizobiaceae</c:v>
                </c:pt>
                <c:pt idx="4">
                  <c:v>Acetobacteraceae</c:v>
                </c:pt>
                <c:pt idx="5">
                  <c:v>Nocardioidaceae</c:v>
                </c:pt>
                <c:pt idx="6">
                  <c:v>Xanthomonadaceae</c:v>
                </c:pt>
                <c:pt idx="7">
                  <c:v>Cytophagaceae</c:v>
                </c:pt>
                <c:pt idx="8">
                  <c:v>Spirochaetaceae</c:v>
                </c:pt>
                <c:pt idx="9">
                  <c:v>Planctomycetaceae</c:v>
                </c:pt>
              </c:strCache>
            </c:strRef>
          </c:cat>
          <c:val>
            <c:numRef>
              <c:f>Family!$X$798:$X$807</c:f>
              <c:numCache>
                <c:formatCode>0.00%</c:formatCode>
                <c:ptCount val="10"/>
                <c:pt idx="0">
                  <c:v>7.8191393264549991E-2</c:v>
                </c:pt>
                <c:pt idx="1">
                  <c:v>5.1226439618550001E-2</c:v>
                </c:pt>
                <c:pt idx="2">
                  <c:v>2.667428284685E-2</c:v>
                </c:pt>
                <c:pt idx="3">
                  <c:v>9.7649642776550007E-3</c:v>
                </c:pt>
                <c:pt idx="4">
                  <c:v>8.4154436022975E-3</c:v>
                </c:pt>
                <c:pt idx="5">
                  <c:v>1.40557038914675E-2</c:v>
                </c:pt>
                <c:pt idx="6">
                  <c:v>4.5372338859124995E-3</c:v>
                </c:pt>
                <c:pt idx="7">
                  <c:v>8.8428878064574998E-4</c:v>
                </c:pt>
                <c:pt idx="8">
                  <c:v>3.8116300278375004E-3</c:v>
                </c:pt>
                <c:pt idx="9">
                  <c:v>2.02879467088499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0F7-47B5-93C8-2B2ACDC3A0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1367670175"/>
        <c:axId val="1367669759"/>
      </c:barChart>
      <c:catAx>
        <c:axId val="13676701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7669759"/>
        <c:crosses val="autoZero"/>
        <c:auto val="1"/>
        <c:lblAlgn val="ctr"/>
        <c:lblOffset val="100"/>
        <c:noMultiLvlLbl val="0"/>
      </c:catAx>
      <c:valAx>
        <c:axId val="1367669759"/>
        <c:scaling>
          <c:orientation val="minMax"/>
          <c:max val="0.1"/>
        </c:scaling>
        <c:delete val="0"/>
        <c:axPos val="l"/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7670175"/>
        <c:crosses val="autoZero"/>
        <c:crossBetween val="between"/>
        <c:majorUnit val="2.0000000000000004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Order!$T$530</c:f>
              <c:strCache>
                <c:ptCount val="1"/>
                <c:pt idx="0">
                  <c:v>MA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Order!$S$531:$S$535</c:f>
              <c:strCache>
                <c:ptCount val="5"/>
                <c:pt idx="0">
                  <c:v>Rhizobiales</c:v>
                </c:pt>
                <c:pt idx="1">
                  <c:v>Chitinophagales</c:v>
                </c:pt>
                <c:pt idx="2">
                  <c:v>Propionibacteriales</c:v>
                </c:pt>
                <c:pt idx="3">
                  <c:v>Spirochaetales</c:v>
                </c:pt>
                <c:pt idx="4">
                  <c:v>Planctomycetales</c:v>
                </c:pt>
              </c:strCache>
            </c:strRef>
          </c:cat>
          <c:val>
            <c:numRef>
              <c:f>Order!$T$531:$T$535</c:f>
              <c:numCache>
                <c:formatCode>0.00%</c:formatCode>
                <c:ptCount val="5"/>
                <c:pt idx="0">
                  <c:v>7.2941463702100001E-2</c:v>
                </c:pt>
                <c:pt idx="1">
                  <c:v>9.6183093110800005E-2</c:v>
                </c:pt>
                <c:pt idx="2">
                  <c:v>7.0436063980524998E-3</c:v>
                </c:pt>
                <c:pt idx="3">
                  <c:v>1.267138053523E-3</c:v>
                </c:pt>
                <c:pt idx="4">
                  <c:v>1.1767360520182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FE-4FEC-8384-EE387394FC78}"/>
            </c:ext>
          </c:extLst>
        </c:ser>
        <c:ser>
          <c:idx val="1"/>
          <c:order val="1"/>
          <c:tx>
            <c:strRef>
              <c:f>Order!$U$530</c:f>
              <c:strCache>
                <c:ptCount val="1"/>
                <c:pt idx="0">
                  <c:v>NMT.MA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Order!$S$531:$S$535</c:f>
              <c:strCache>
                <c:ptCount val="5"/>
                <c:pt idx="0">
                  <c:v>Rhizobiales</c:v>
                </c:pt>
                <c:pt idx="1">
                  <c:v>Chitinophagales</c:v>
                </c:pt>
                <c:pt idx="2">
                  <c:v>Propionibacteriales</c:v>
                </c:pt>
                <c:pt idx="3">
                  <c:v>Spirochaetales</c:v>
                </c:pt>
                <c:pt idx="4">
                  <c:v>Planctomycetales</c:v>
                </c:pt>
              </c:strCache>
            </c:strRef>
          </c:cat>
          <c:val>
            <c:numRef>
              <c:f>Order!$U$531:$U$535</c:f>
              <c:numCache>
                <c:formatCode>0.00%</c:formatCode>
                <c:ptCount val="5"/>
                <c:pt idx="0">
                  <c:v>9.2517304364375011E-2</c:v>
                </c:pt>
                <c:pt idx="1">
                  <c:v>9.9031919489100007E-2</c:v>
                </c:pt>
                <c:pt idx="2">
                  <c:v>4.1171517885599997E-3</c:v>
                </c:pt>
                <c:pt idx="3">
                  <c:v>1.5593604680375001E-3</c:v>
                </c:pt>
                <c:pt idx="4">
                  <c:v>1.222976957054249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5FE-4FEC-8384-EE387394FC78}"/>
            </c:ext>
          </c:extLst>
        </c:ser>
        <c:ser>
          <c:idx val="2"/>
          <c:order val="2"/>
          <c:tx>
            <c:strRef>
              <c:f>Order!$V$530</c:f>
              <c:strCache>
                <c:ptCount val="1"/>
                <c:pt idx="0">
                  <c:v>NMT.MAA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Order!$S$531:$S$535</c:f>
              <c:strCache>
                <c:ptCount val="5"/>
                <c:pt idx="0">
                  <c:v>Rhizobiales</c:v>
                </c:pt>
                <c:pt idx="1">
                  <c:v>Chitinophagales</c:v>
                </c:pt>
                <c:pt idx="2">
                  <c:v>Propionibacteriales</c:v>
                </c:pt>
                <c:pt idx="3">
                  <c:v>Spirochaetales</c:v>
                </c:pt>
                <c:pt idx="4">
                  <c:v>Planctomycetales</c:v>
                </c:pt>
              </c:strCache>
            </c:strRef>
          </c:cat>
          <c:val>
            <c:numRef>
              <c:f>Order!$V$531:$V$535</c:f>
              <c:numCache>
                <c:formatCode>0.00%</c:formatCode>
                <c:ptCount val="5"/>
                <c:pt idx="0">
                  <c:v>0.104009511452475</c:v>
                </c:pt>
                <c:pt idx="1">
                  <c:v>7.8191393264549991E-2</c:v>
                </c:pt>
                <c:pt idx="2">
                  <c:v>1.40557038914675E-2</c:v>
                </c:pt>
                <c:pt idx="3">
                  <c:v>3.8116300278375004E-3</c:v>
                </c:pt>
                <c:pt idx="4">
                  <c:v>2.954918495019999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5FE-4FEC-8384-EE387394FC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1507797439"/>
        <c:axId val="1507798687"/>
      </c:barChart>
      <c:catAx>
        <c:axId val="15077974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507798687"/>
        <c:crosses val="autoZero"/>
        <c:auto val="1"/>
        <c:lblAlgn val="ctr"/>
        <c:lblOffset val="100"/>
        <c:noMultiLvlLbl val="0"/>
      </c:catAx>
      <c:valAx>
        <c:axId val="1507798687"/>
        <c:scaling>
          <c:orientation val="minMax"/>
          <c:max val="0.1"/>
        </c:scaling>
        <c:delete val="0"/>
        <c:axPos val="l"/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507797439"/>
        <c:crosses val="autoZero"/>
        <c:crossBetween val="between"/>
        <c:majorUnit val="2.0000000000000004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lass!$W$235</c:f>
              <c:strCache>
                <c:ptCount val="1"/>
                <c:pt idx="0">
                  <c:v>MA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Class!$V$236:$V$238</c:f>
              <c:strCache>
                <c:ptCount val="3"/>
                <c:pt idx="0">
                  <c:v>Chitinophagia</c:v>
                </c:pt>
                <c:pt idx="1">
                  <c:v>Spirochaetia</c:v>
                </c:pt>
                <c:pt idx="2">
                  <c:v>Planctomycetia</c:v>
                </c:pt>
              </c:strCache>
            </c:strRef>
          </c:cat>
          <c:val>
            <c:numRef>
              <c:f>Class!$W$236:$W$238</c:f>
              <c:numCache>
                <c:formatCode>0.00%</c:formatCode>
                <c:ptCount val="3"/>
                <c:pt idx="0">
                  <c:v>9.6183093110800005E-2</c:v>
                </c:pt>
                <c:pt idx="1">
                  <c:v>1.267138053523E-3</c:v>
                </c:pt>
                <c:pt idx="2">
                  <c:v>1.1767360520182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13A-4B46-908B-06782E5D3F15}"/>
            </c:ext>
          </c:extLst>
        </c:ser>
        <c:ser>
          <c:idx val="1"/>
          <c:order val="1"/>
          <c:tx>
            <c:strRef>
              <c:f>Class!$X$235</c:f>
              <c:strCache>
                <c:ptCount val="1"/>
                <c:pt idx="0">
                  <c:v>NMT.MA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Class!$V$236:$V$238</c:f>
              <c:strCache>
                <c:ptCount val="3"/>
                <c:pt idx="0">
                  <c:v>Chitinophagia</c:v>
                </c:pt>
                <c:pt idx="1">
                  <c:v>Spirochaetia</c:v>
                </c:pt>
                <c:pt idx="2">
                  <c:v>Planctomycetia</c:v>
                </c:pt>
              </c:strCache>
            </c:strRef>
          </c:cat>
          <c:val>
            <c:numRef>
              <c:f>Class!$X$236:$X$238</c:f>
              <c:numCache>
                <c:formatCode>0.00%</c:formatCode>
                <c:ptCount val="3"/>
                <c:pt idx="0">
                  <c:v>9.9031919489100007E-2</c:v>
                </c:pt>
                <c:pt idx="1">
                  <c:v>1.5898799089212501E-3</c:v>
                </c:pt>
                <c:pt idx="2">
                  <c:v>1.222976957054249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13A-4B46-908B-06782E5D3F15}"/>
            </c:ext>
          </c:extLst>
        </c:ser>
        <c:ser>
          <c:idx val="2"/>
          <c:order val="2"/>
          <c:tx>
            <c:strRef>
              <c:f>Class!$Y$235</c:f>
              <c:strCache>
                <c:ptCount val="1"/>
                <c:pt idx="0">
                  <c:v>NMT.MAA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Class!$V$236:$V$238</c:f>
              <c:strCache>
                <c:ptCount val="3"/>
                <c:pt idx="0">
                  <c:v>Chitinophagia</c:v>
                </c:pt>
                <c:pt idx="1">
                  <c:v>Spirochaetia</c:v>
                </c:pt>
                <c:pt idx="2">
                  <c:v>Planctomycetia</c:v>
                </c:pt>
              </c:strCache>
            </c:strRef>
          </c:cat>
          <c:val>
            <c:numRef>
              <c:f>Class!$Y$236:$Y$238</c:f>
              <c:numCache>
                <c:formatCode>0.00%</c:formatCode>
                <c:ptCount val="3"/>
                <c:pt idx="0">
                  <c:v>7.8191393264549991E-2</c:v>
                </c:pt>
                <c:pt idx="1">
                  <c:v>3.8362266433424998E-3</c:v>
                </c:pt>
                <c:pt idx="2">
                  <c:v>2.954918495019999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13A-4B46-908B-06782E5D3F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1360935135"/>
        <c:axId val="1360910175"/>
      </c:barChart>
      <c:catAx>
        <c:axId val="13609351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0910175"/>
        <c:crosses val="autoZero"/>
        <c:auto val="1"/>
        <c:lblAlgn val="ctr"/>
        <c:lblOffset val="100"/>
        <c:noMultiLvlLbl val="0"/>
      </c:catAx>
      <c:valAx>
        <c:axId val="1360910175"/>
        <c:scaling>
          <c:orientation val="minMax"/>
          <c:max val="0.1"/>
        </c:scaling>
        <c:delete val="0"/>
        <c:axPos val="l"/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0935135"/>
        <c:crosses val="autoZero"/>
        <c:crossBetween val="between"/>
        <c:majorUnit val="2.0000000000000004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hylum!$U$143</c:f>
              <c:strCache>
                <c:ptCount val="1"/>
                <c:pt idx="0">
                  <c:v>MAN.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Phylum!$T$144:$T$146</c:f>
              <c:strCache>
                <c:ptCount val="3"/>
                <c:pt idx="0">
                  <c:v>Planctomycetes</c:v>
                </c:pt>
                <c:pt idx="1">
                  <c:v>Spirochaetes</c:v>
                </c:pt>
                <c:pt idx="2">
                  <c:v>Cyanobacteria</c:v>
                </c:pt>
              </c:strCache>
            </c:strRef>
          </c:cat>
          <c:val>
            <c:numRef>
              <c:f>Phylum!$U$144:$U$146</c:f>
              <c:numCache>
                <c:formatCode>0.00%</c:formatCode>
                <c:ptCount val="3"/>
                <c:pt idx="0">
                  <c:v>3.7001345521374997E-3</c:v>
                </c:pt>
                <c:pt idx="1">
                  <c:v>1.267138053523E-3</c:v>
                </c:pt>
                <c:pt idx="2">
                  <c:v>9.9562955042875015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6F-48A1-900F-07ED4128EF4F}"/>
            </c:ext>
          </c:extLst>
        </c:ser>
        <c:ser>
          <c:idx val="1"/>
          <c:order val="1"/>
          <c:tx>
            <c:strRef>
              <c:f>Phylum!$V$143</c:f>
              <c:strCache>
                <c:ptCount val="1"/>
                <c:pt idx="0">
                  <c:v>NMT.MAC.4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Phylum!$T$144:$T$146</c:f>
              <c:strCache>
                <c:ptCount val="3"/>
                <c:pt idx="0">
                  <c:v>Planctomycetes</c:v>
                </c:pt>
                <c:pt idx="1">
                  <c:v>Spirochaetes</c:v>
                </c:pt>
                <c:pt idx="2">
                  <c:v>Cyanobacteria</c:v>
                </c:pt>
              </c:strCache>
            </c:strRef>
          </c:cat>
          <c:val>
            <c:numRef>
              <c:f>Phylum!$V$144:$V$146</c:f>
              <c:numCache>
                <c:formatCode>0.00%</c:formatCode>
                <c:ptCount val="3"/>
                <c:pt idx="0">
                  <c:v>3.6745602892899998E-3</c:v>
                </c:pt>
                <c:pt idx="1">
                  <c:v>1.5898799089212501E-3</c:v>
                </c:pt>
                <c:pt idx="2">
                  <c:v>8.579131359625000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6F-48A1-900F-07ED4128EF4F}"/>
            </c:ext>
          </c:extLst>
        </c:ser>
        <c:ser>
          <c:idx val="2"/>
          <c:order val="2"/>
          <c:tx>
            <c:strRef>
              <c:f>Phylum!$W$143</c:f>
              <c:strCache>
                <c:ptCount val="1"/>
                <c:pt idx="0">
                  <c:v>NMT.MAA.4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Phylum!$T$144:$T$146</c:f>
              <c:strCache>
                <c:ptCount val="3"/>
                <c:pt idx="0">
                  <c:v>Planctomycetes</c:v>
                </c:pt>
                <c:pt idx="1">
                  <c:v>Spirochaetes</c:v>
                </c:pt>
                <c:pt idx="2">
                  <c:v>Cyanobacteria</c:v>
                </c:pt>
              </c:strCache>
            </c:strRef>
          </c:cat>
          <c:val>
            <c:numRef>
              <c:f>Phylum!$W$144:$W$146</c:f>
              <c:numCache>
                <c:formatCode>0.00%</c:formatCode>
                <c:ptCount val="3"/>
                <c:pt idx="0">
                  <c:v>6.1471792006124997E-3</c:v>
                </c:pt>
                <c:pt idx="1">
                  <c:v>3.8362266433424998E-3</c:v>
                </c:pt>
                <c:pt idx="2">
                  <c:v>1.687177193621250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06F-48A1-900F-07ED4128EF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1360921823"/>
        <c:axId val="1360932639"/>
      </c:barChart>
      <c:catAx>
        <c:axId val="13609218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0932639"/>
        <c:crosses val="autoZero"/>
        <c:auto val="1"/>
        <c:lblAlgn val="ctr"/>
        <c:lblOffset val="100"/>
        <c:noMultiLvlLbl val="0"/>
      </c:catAx>
      <c:valAx>
        <c:axId val="1360932639"/>
        <c:scaling>
          <c:orientation val="minMax"/>
          <c:max val="6.0000000000000019E-3"/>
        </c:scaling>
        <c:delete val="0"/>
        <c:axPos val="l"/>
        <c:numFmt formatCode="0.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60921823"/>
        <c:crosses val="autoZero"/>
        <c:crossBetween val="between"/>
        <c:majorUnit val="2.0000000000000005E-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051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913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747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825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703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340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871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160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7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309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494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F9300A-8209-4B31-80AA-731D25560EF3}" type="datetimeFigureOut">
              <a:rPr lang="en-US" smtClean="0"/>
              <a:t>6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312F4-95B3-44DB-8597-89B870B65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486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그림 4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935" y="1815769"/>
            <a:ext cx="5889246" cy="4541914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2E181CF4-27F1-4B95-8DA3-36C707BE0ACC}"/>
              </a:ext>
            </a:extLst>
          </p:cNvPr>
          <p:cNvSpPr txBox="1"/>
          <p:nvPr/>
        </p:nvSpPr>
        <p:spPr>
          <a:xfrm>
            <a:off x="315935" y="7293388"/>
            <a:ext cx="63375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lative abundance of bacterial taxa at (A) phylum, (B) class, (C) order and (D) family levels in the rhizosphere of pine seedling treated with methyl salicylic acid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ollowed by inoculation with the nematode compared to nematode-inoculated or control seedlings. Only bacterial species that existed in significantly different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5) relative abundance after treatment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ed to the control are shown in the graph. The bars represent the mean values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4)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32345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TextBox 79">
            <a:extLst>
              <a:ext uri="{FF2B5EF4-FFF2-40B4-BE49-F238E27FC236}">
                <a16:creationId xmlns:a16="http://schemas.microsoft.com/office/drawing/2014/main" id="{2E181CF4-27F1-4B95-8DA3-36C707BE0ACC}"/>
              </a:ext>
            </a:extLst>
          </p:cNvPr>
          <p:cNvSpPr txBox="1"/>
          <p:nvPr/>
        </p:nvSpPr>
        <p:spPr>
          <a:xfrm>
            <a:off x="48125" y="7906998"/>
            <a:ext cx="67737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lative abundance of bacterial taxa at (A) phylum, (B) class, (C) order and (D) family levels in the rhizosphere of pine seedling treated with methyl salicylic acid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ollowed by inoculation with the nematode compared to nematode-inoculated or control seedlings. Only bacterial species that existed in significantly different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5) relative abundance after treatment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ed to the control are shown in the graph. The bars represent the mean values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4)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차트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4630110"/>
              </p:ext>
            </p:extLst>
          </p:nvPr>
        </p:nvGraphicFramePr>
        <p:xfrm>
          <a:off x="517711" y="5292561"/>
          <a:ext cx="5660661" cy="21890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차트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939723"/>
              </p:ext>
            </p:extLst>
          </p:nvPr>
        </p:nvGraphicFramePr>
        <p:xfrm>
          <a:off x="529123" y="3314877"/>
          <a:ext cx="4543327" cy="15522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4" name="TextBox 33">
            <a:extLst>
              <a:ext uri="{FF2B5EF4-FFF2-40B4-BE49-F238E27FC236}">
                <a16:creationId xmlns:a16="http://schemas.microsoft.com/office/drawing/2014/main" id="{3305780B-C5DE-4198-8DD5-E7A837AE9D85}"/>
              </a:ext>
            </a:extLst>
          </p:cNvPr>
          <p:cNvSpPr txBox="1"/>
          <p:nvPr/>
        </p:nvSpPr>
        <p:spPr>
          <a:xfrm>
            <a:off x="84221" y="265861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45B5A26-F161-42D7-918A-B16D96A44DB2}"/>
              </a:ext>
            </a:extLst>
          </p:cNvPr>
          <p:cNvSpPr txBox="1"/>
          <p:nvPr/>
        </p:nvSpPr>
        <p:spPr>
          <a:xfrm>
            <a:off x="84221" y="3370874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305780B-C5DE-4198-8DD5-E7A837AE9D85}"/>
              </a:ext>
            </a:extLst>
          </p:cNvPr>
          <p:cNvSpPr txBox="1"/>
          <p:nvPr/>
        </p:nvSpPr>
        <p:spPr>
          <a:xfrm>
            <a:off x="84221" y="1732587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45B5A26-F161-42D7-918A-B16D96A44DB2}"/>
              </a:ext>
            </a:extLst>
          </p:cNvPr>
          <p:cNvSpPr txBox="1"/>
          <p:nvPr/>
        </p:nvSpPr>
        <p:spPr>
          <a:xfrm>
            <a:off x="84221" y="536715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graphicFrame>
        <p:nvGraphicFramePr>
          <p:cNvPr id="50" name="차트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5709814"/>
              </p:ext>
            </p:extLst>
          </p:nvPr>
        </p:nvGraphicFramePr>
        <p:xfrm>
          <a:off x="541157" y="229313"/>
          <a:ext cx="1534138" cy="12287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51" name="그룹 30">
            <a:extLst>
              <a:ext uri="{FF2B5EF4-FFF2-40B4-BE49-F238E27FC236}">
                <a16:creationId xmlns:a16="http://schemas.microsoft.com/office/drawing/2014/main" id="{8054A7F8-5469-4D96-8F87-EC37377D1797}"/>
              </a:ext>
            </a:extLst>
          </p:cNvPr>
          <p:cNvGrpSpPr/>
          <p:nvPr/>
        </p:nvGrpSpPr>
        <p:grpSpPr>
          <a:xfrm>
            <a:off x="5075453" y="5521044"/>
            <a:ext cx="1102919" cy="634552"/>
            <a:chOff x="4346654" y="7764930"/>
            <a:chExt cx="1102919" cy="634552"/>
          </a:xfrm>
        </p:grpSpPr>
        <p:sp>
          <p:nvSpPr>
            <p:cNvPr id="52" name="직사각형 21">
              <a:extLst>
                <a:ext uri="{FF2B5EF4-FFF2-40B4-BE49-F238E27FC236}">
                  <a16:creationId xmlns:a16="http://schemas.microsoft.com/office/drawing/2014/main" id="{72458988-8F06-4D08-9B60-F65B47751A38}"/>
                </a:ext>
              </a:extLst>
            </p:cNvPr>
            <p:cNvSpPr/>
            <p:nvPr/>
          </p:nvSpPr>
          <p:spPr>
            <a:xfrm>
              <a:off x="5183701" y="8227613"/>
              <a:ext cx="176666" cy="84221"/>
            </a:xfrm>
            <a:prstGeom prst="rect">
              <a:avLst/>
            </a:prstGeom>
            <a:solidFill>
              <a:srgbClr val="6EE96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직사각형 22">
              <a:extLst>
                <a:ext uri="{FF2B5EF4-FFF2-40B4-BE49-F238E27FC236}">
                  <a16:creationId xmlns:a16="http://schemas.microsoft.com/office/drawing/2014/main" id="{25B4EA61-1310-4D10-8D0B-6A93314BB5FB}"/>
                </a:ext>
              </a:extLst>
            </p:cNvPr>
            <p:cNvSpPr/>
            <p:nvPr/>
          </p:nvSpPr>
          <p:spPr>
            <a:xfrm>
              <a:off x="5183701" y="8037593"/>
              <a:ext cx="176666" cy="84221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직사각형 23">
              <a:extLst>
                <a:ext uri="{FF2B5EF4-FFF2-40B4-BE49-F238E27FC236}">
                  <a16:creationId xmlns:a16="http://schemas.microsoft.com/office/drawing/2014/main" id="{6C246DF5-D7ED-46F2-984A-D87C3704EBD2}"/>
                </a:ext>
              </a:extLst>
            </p:cNvPr>
            <p:cNvSpPr/>
            <p:nvPr/>
          </p:nvSpPr>
          <p:spPr>
            <a:xfrm>
              <a:off x="5183701" y="7833855"/>
              <a:ext cx="176666" cy="84221"/>
            </a:xfrm>
            <a:prstGeom prst="rect">
              <a:avLst/>
            </a:prstGeom>
            <a:solidFill>
              <a:srgbClr val="4472C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직사각형 25">
              <a:extLst>
                <a:ext uri="{FF2B5EF4-FFF2-40B4-BE49-F238E27FC236}">
                  <a16:creationId xmlns:a16="http://schemas.microsoft.com/office/drawing/2014/main" id="{99498710-EC38-49BE-A759-CED0F2A6A562}"/>
                </a:ext>
              </a:extLst>
            </p:cNvPr>
            <p:cNvSpPr/>
            <p:nvPr/>
          </p:nvSpPr>
          <p:spPr>
            <a:xfrm>
              <a:off x="4346654" y="7764930"/>
              <a:ext cx="1102919" cy="63455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AF3E09F3-9F10-400D-8215-796455E55D21}"/>
                </a:ext>
              </a:extLst>
            </p:cNvPr>
            <p:cNvSpPr txBox="1"/>
            <p:nvPr/>
          </p:nvSpPr>
          <p:spPr>
            <a:xfrm>
              <a:off x="4698840" y="7776816"/>
              <a:ext cx="50366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F3BF7988-FC2D-4B9D-B94A-EE231D84C7A3}"/>
                </a:ext>
              </a:extLst>
            </p:cNvPr>
            <p:cNvSpPr txBox="1"/>
            <p:nvPr/>
          </p:nvSpPr>
          <p:spPr>
            <a:xfrm>
              <a:off x="4585027" y="7972381"/>
              <a:ext cx="61747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Nematode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66FF0DE7-109E-424B-A79D-65E4B2830F18}"/>
                </a:ext>
              </a:extLst>
            </p:cNvPr>
            <p:cNvSpPr txBox="1"/>
            <p:nvPr/>
          </p:nvSpPr>
          <p:spPr>
            <a:xfrm>
              <a:off x="4769372" y="8170089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eSA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60" name="차트 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4636395"/>
              </p:ext>
            </p:extLst>
          </p:nvPr>
        </p:nvGraphicFramePr>
        <p:xfrm>
          <a:off x="517711" y="1666916"/>
          <a:ext cx="3766190" cy="14017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40195125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차트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7904857"/>
              </p:ext>
            </p:extLst>
          </p:nvPr>
        </p:nvGraphicFramePr>
        <p:xfrm>
          <a:off x="529122" y="5342014"/>
          <a:ext cx="5150642" cy="21207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차트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9553725"/>
              </p:ext>
            </p:extLst>
          </p:nvPr>
        </p:nvGraphicFramePr>
        <p:xfrm>
          <a:off x="529123" y="3378984"/>
          <a:ext cx="3609740" cy="17761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차트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4418810"/>
              </p:ext>
            </p:extLst>
          </p:nvPr>
        </p:nvGraphicFramePr>
        <p:xfrm>
          <a:off x="529123" y="1803184"/>
          <a:ext cx="2835170" cy="13005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차트 12"/>
          <p:cNvGraphicFramePr>
            <a:graphicFrameLocks/>
          </p:cNvGraphicFramePr>
          <p:nvPr/>
        </p:nvGraphicFramePr>
        <p:xfrm>
          <a:off x="529123" y="215141"/>
          <a:ext cx="2835171" cy="13118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3305780B-C5DE-4198-8DD5-E7A837AE9D85}"/>
              </a:ext>
            </a:extLst>
          </p:cNvPr>
          <p:cNvSpPr txBox="1"/>
          <p:nvPr/>
        </p:nvSpPr>
        <p:spPr>
          <a:xfrm>
            <a:off x="95992" y="233632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45B5A26-F161-42D7-918A-B16D96A44DB2}"/>
              </a:ext>
            </a:extLst>
          </p:cNvPr>
          <p:cNvSpPr txBox="1"/>
          <p:nvPr/>
        </p:nvSpPr>
        <p:spPr>
          <a:xfrm>
            <a:off x="95992" y="356584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305780B-C5DE-4198-8DD5-E7A837AE9D85}"/>
              </a:ext>
            </a:extLst>
          </p:cNvPr>
          <p:cNvSpPr txBox="1"/>
          <p:nvPr/>
        </p:nvSpPr>
        <p:spPr>
          <a:xfrm>
            <a:off x="108025" y="1999441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45B5A26-F161-42D7-918A-B16D96A44DB2}"/>
              </a:ext>
            </a:extLst>
          </p:cNvPr>
          <p:cNvSpPr txBox="1"/>
          <p:nvPr/>
        </p:nvSpPr>
        <p:spPr>
          <a:xfrm>
            <a:off x="108025" y="587342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5231A14-B4B5-4698-836D-EC7AA15B852C}"/>
              </a:ext>
            </a:extLst>
          </p:cNvPr>
          <p:cNvSpPr txBox="1"/>
          <p:nvPr/>
        </p:nvSpPr>
        <p:spPr>
          <a:xfrm>
            <a:off x="108025" y="7730778"/>
            <a:ext cx="66060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ar graphs representing the relative abundance of bacterial taxa at (A) phylum, (B) class, (C) order and (D) family levels, present at significantly (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&lt; 0.05) different levels in pine seedlings treated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cibenzola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-s-methyl (ASM), followed by inoculation with the nematode, compared to nematode-treated or control seedlings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20" name="그룹 19"/>
          <p:cNvGrpSpPr/>
          <p:nvPr/>
        </p:nvGrpSpPr>
        <p:grpSpPr>
          <a:xfrm>
            <a:off x="5000580" y="5671643"/>
            <a:ext cx="1102919" cy="634552"/>
            <a:chOff x="4346654" y="7764930"/>
            <a:chExt cx="1102919" cy="634552"/>
          </a:xfrm>
        </p:grpSpPr>
        <p:sp>
          <p:nvSpPr>
            <p:cNvPr id="21" name="직사각형 20"/>
            <p:cNvSpPr/>
            <p:nvPr/>
          </p:nvSpPr>
          <p:spPr>
            <a:xfrm>
              <a:off x="5183701" y="8227613"/>
              <a:ext cx="176666" cy="84221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5183701" y="8037593"/>
              <a:ext cx="176666" cy="84221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직사각형 22"/>
            <p:cNvSpPr/>
            <p:nvPr/>
          </p:nvSpPr>
          <p:spPr>
            <a:xfrm>
              <a:off x="5183701" y="7833855"/>
              <a:ext cx="176666" cy="84221"/>
            </a:xfrm>
            <a:prstGeom prst="rect">
              <a:avLst/>
            </a:prstGeom>
            <a:solidFill>
              <a:srgbClr val="4472C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직사각형 23"/>
            <p:cNvSpPr/>
            <p:nvPr/>
          </p:nvSpPr>
          <p:spPr>
            <a:xfrm>
              <a:off x="4346654" y="7764930"/>
              <a:ext cx="1102919" cy="63455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698840" y="7776816"/>
              <a:ext cx="50366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585027" y="7972381"/>
              <a:ext cx="61747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Nematode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819066" y="8170089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S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19260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2551</TotalTime>
  <Words>295</Words>
  <Application>Microsoft Office PowerPoint</Application>
  <PresentationFormat>A4 Paper (210x297 mm)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CIAGUEDEZ,DANIELAALEJANDRA</dc:creator>
  <cp:lastModifiedBy>Marta</cp:lastModifiedBy>
  <cp:revision>163</cp:revision>
  <dcterms:created xsi:type="dcterms:W3CDTF">2019-11-10T06:23:34Z</dcterms:created>
  <dcterms:modified xsi:type="dcterms:W3CDTF">2020-06-05T08:40:52Z</dcterms:modified>
</cp:coreProperties>
</file>